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89F3C-ADAB-002D-2569-0FC120A34E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312C4B-1560-1D8D-491F-91F9BE30AA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4EB220-D7CC-D619-86AB-31F50446E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4F48C3-4E35-0CA0-9028-CA0CBF665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ABFD6-4889-910F-B5F0-A9FEDBEB6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4309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3E9854-8DC3-67B9-E80D-143EBC311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FC82BA-4537-8E90-C554-BD0F48D3FC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F1C43E-0596-A7FC-F605-A7DBA746C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5836AF-27B6-B661-FCBD-3FFBE9CD6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E243BA-49AE-FCF4-A1E4-68ECA4BA7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0531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0DF490-0EB3-7CA0-FFB7-01BFA8DA1A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82C52A-51BC-E12B-A4FA-A8E1EC6F60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42E484-8380-2E28-6C58-2E51E06BC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57D0F-31C0-58F4-EA42-99B85DE27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2E307B-BA50-52EC-B6B3-F63A4ADAA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39532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E84A2-E73A-BC8C-75B8-6A00F0968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237E4E-DC4E-40F7-DF7E-3139559E0F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A9CBA-874C-A223-C90C-8FD24283B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CAE579-998B-7CDF-19AC-62D7C55D5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9BE9D4-01AB-0925-4FCE-FC94F1DE1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60516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3D8744-B954-11F7-C631-3AD3509E64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BE70D6-20F2-0DA4-BB13-F4BBB2740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004333-F708-46EA-D30B-8AD4BA9DD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2CCFE-4C65-FCBE-CE28-3056DAD89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8EB63E-B93E-3B08-C2D3-87D4AD0E5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77987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62FF65-7428-E710-E869-789C240C1B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1D0D13-2638-3682-2F6A-23D6FC8CC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C39D61-63D4-DB8C-6FFF-7E5E3A8086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19EB04-09C8-7C6A-29F3-B33A2642C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8F2E2F-AB64-9576-7752-9403C9344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EAC08F-85B9-B6C3-4E7D-D5FF5F6C5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97813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7DB7D-FCA1-1869-20D1-9C8396200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5CFCF6-BBC2-3F89-1C3E-C5857FFB53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70A17F-B5AE-FB33-74E5-3702DEFE20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0C7A30-0B0A-2A20-5993-48CF941341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A048ED-47D8-D0D1-FFE2-38702C24AE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8C5437-F253-E1AA-21B6-B5EA28442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C4F30E-5F2E-559F-B359-738922311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272C84C-AE1A-1E17-E56B-CDE3403E2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52259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647E25-6FAE-5DE5-CFAC-41AA784BA5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8666D1-C760-E74D-DF7B-043DD8667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E56C885-EA56-3283-AE36-427057C3E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FE8D8C-1C1D-DFB6-AAC7-11EFFABB8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96681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8C6627-ADC1-389B-0C15-37D603266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FFC493-9611-0E6F-8ED3-C02C34E20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40482D-D105-7795-3637-1745631FE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72451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EE645-738E-51AC-1149-A47A9009E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6020ED-FA4F-63A4-FB43-FB456302A0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3E3C59-8A5B-F85F-B0C9-DCDB8CAC31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A624C9-B7BE-EC40-7585-A7EC1D326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AC7676-7254-0C07-80CE-E1E47C439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AC39BF-A830-9727-BFAB-CAAD9EF6A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47299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B0129E-C852-8BAE-1B7E-DB6BEE8BB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A8347D-A38A-1E81-B046-B8435A1026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66B232-C569-79E7-27C0-22A9E0AE3F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8CD95E-9770-5314-5294-403E7FC08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FF1411-EACC-849A-B65A-26E9FAD74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D7B238-AC0C-B351-DB21-2E3F684E7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58928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DEC867-7E17-923A-2DD2-608188A89B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0040E0-0119-05A2-35D1-8099F69CAA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7B1D35-A53F-66BD-8006-2A34578C0A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C069B-0E3E-4169-B70C-ABD7B294E7B9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4B268-D0FE-7249-98AC-FF8A1F2903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E383A3-647B-EC8D-59C1-D44FCC93EE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B7AFD5-3347-4791-9633-2B71AA6023D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55993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50D94B9-72B3-B9C0-8283-4C6BDF9B4D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176" y="74453"/>
            <a:ext cx="10419127" cy="586075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C56F813-B109-64CE-AA8B-61EA5ECF801F}"/>
              </a:ext>
            </a:extLst>
          </p:cNvPr>
          <p:cNvSpPr txBox="1"/>
          <p:nvPr/>
        </p:nvSpPr>
        <p:spPr>
          <a:xfrm>
            <a:off x="536895" y="6241409"/>
            <a:ext cx="110566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8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 histogram with the number of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uraphis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xi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anscripts plotted over their total relative combined expression for 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xi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iotypes RWA-SA1 and RWA-SAM. </a:t>
            </a:r>
            <a:endParaRPr lang="en-Z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6768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Dr [nfvburger@sun.ac.za]</dc:creator>
  <cp:lastModifiedBy>Oberholster, A, Prof [ambo@sun.ac.za]</cp:lastModifiedBy>
  <cp:revision>4</cp:revision>
  <dcterms:created xsi:type="dcterms:W3CDTF">2023-09-29T08:57:54Z</dcterms:created>
  <dcterms:modified xsi:type="dcterms:W3CDTF">2024-01-17T12:40:27Z</dcterms:modified>
</cp:coreProperties>
</file>